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22F30-67F0-4C47-9FCB-2B6CA93FDE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B6B67F-D21C-41A1-B3CF-6DDAB5CBE1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228BF7-D8D3-425F-BFD2-3EE59EDCA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3FE877-4685-40DB-8349-DAFC43332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6887A4-E991-4EBC-93FA-367BF0072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91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7E0698-D189-49F1-B5B6-0DEE8AAD81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EB655E-DA8A-4A6E-B099-11368745EB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D7E20-EBEE-4B49-96EB-BFD2CDA09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F42F71-405C-4F4A-8665-32FA4422E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CEE36C-D85D-4BB9-8F69-162729072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826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1A08F1-F559-4654-BC4C-B9B41BE9C0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3DAEBC-8B5F-45E9-9DB8-A5DD6EC945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18F012-BCF8-4868-9F02-61ADB8C4B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25E3D6-75FE-4CD8-94F5-DAA9259AB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331ABB-B725-428C-B2C0-9EFC23D26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7273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13A5C-14B3-43B9-BFBC-689A1B5C6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20563A-ABD7-43E3-95C7-B8EBEB3FE2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B5E81-A1AE-4A5E-8A9A-FAACD4801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14F949-86C8-48EF-9D82-7B35247F9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9B648C-224C-4017-8ECB-3207A7F42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4908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DA2EEF-F9EA-4C59-B169-1C22709E5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DB21B0-177C-4540-9F02-AA45D5EE48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812EE-B49E-40C5-AC2E-B63EA6297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01EA8-FECB-463D-958E-1F9A20553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C287FA-A54F-4FCE-A194-5953A78C8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637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2C7C6F-742D-4FBE-8378-5E55338098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6D75BD-07DD-41C6-9163-D3B0275ED3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888651-DD84-4BB7-9D43-540C61DD03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2B0863-DCE8-4788-A43D-D5EBDCFA0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2155B1-785C-4C8A-A7AF-BBF447514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A1158E-5FF8-4165-A489-234B537D0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4179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BED9BC-EBE9-4247-834A-B50E43A7C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37568-49A4-4969-B693-9A9661CFB8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614CCC-E137-4E32-8549-9BF63D5C0C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1A8C8A-C6F7-494F-8257-CCFFEE82A7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87BC1B-B564-46AF-B508-BF8B85B72E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9CAB3D-E4DF-4D53-AEBC-1FA9E53F9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AB5A9C-7988-4214-8AEB-CCFB368FF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73BECB-1E39-48E0-A367-22A6EB3A5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7125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8CDBB-FB4C-425F-910F-86F78B016D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C48F24-1490-4054-9392-C042C1E83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FD15AF-0C63-4A12-97A2-4167F8626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40EA516-95E1-4B17-9A24-7730F8F06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6965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19AC49-F257-48B0-A095-FE1DA5B46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ECCB3F-A71A-4A2C-AACF-70BD670BD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55F2AD-16F1-4F76-83ED-09E4EE55B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978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A161BF-2F2D-4B26-BAF8-65F72CD6E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B88808-BCD4-46AF-884D-D1057513EB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9C4D90-6543-4149-9A32-AC813DB863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DFCD60-C593-4D21-B32B-6886A58CD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8F3148-2B12-404F-985D-A73AB11A1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52D92D-9D18-4E26-9B8C-0635D3ACC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050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80CDFB-EDF3-4AD0-9A60-765683310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03F82B-78FF-46CB-B59E-183F2377A0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D6480A-1B5E-49E3-811E-713AE9341B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C9DBB2-797D-4626-A047-DDACBDB39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ED8CEA-6AA0-48B1-9C12-840AB5FC0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E23FA0-E8F2-40CB-8B42-A93E5E98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1862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8AAAD8-5E31-4FD8-8B26-94B4A75142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381945-3153-4CDF-952A-D9EE1C927D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E66152-0E9A-4D9F-A100-F38A58985E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97A88-9A8D-4E40-B87C-D14DD4D90E16}" type="datetimeFigureOut">
              <a:rPr lang="en-GB" smtClean="0"/>
              <a:t>16/06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5CBDD5-AA08-4065-853A-1341CCFFF6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84EB9B-8DF1-421D-850E-50832F987C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5AE9A-F105-43DD-842E-64DB8A2CE6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158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D48564-EB4E-48FC-BDBC-DD0CE01DB39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3745" y="534392"/>
            <a:ext cx="4016836" cy="4261544"/>
          </a:xfrm>
          <a:prstGeom prst="rect">
            <a:avLst/>
          </a:prstGeom>
          <a:noFill/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09FEC87-E771-4A39-90B2-C5616F68B824}"/>
              </a:ext>
            </a:extLst>
          </p:cNvPr>
          <p:cNvSpPr txBox="1"/>
          <p:nvPr/>
        </p:nvSpPr>
        <p:spPr>
          <a:xfrm>
            <a:off x="619858" y="4873400"/>
            <a:ext cx="820535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2 – Detection of cell types dispersed from lung parenchyma tissues infected ex vivo with influenza virus and mediator secretion resulting from that infection. 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ung tissues were rested overnight and then infected for 2 h with influenza virus or mock-infected with U.V. treated virus (see Methods section for details).  A) Lung tissues were then digested with Collagenase 1 and the dispersed cells were identified using cell surface markers specific to each cell type (CD8- T lymphocytes, CD8+ T lymphocytes, macrophages, epithelial cells and fibroblasts. Infection of epithelial cells and macrophages was measured over time up to 48 h post-exposure to influenza virus showing the optimal infection time-point to be 24 h.  B) Secretion of cytokines and chemokines into the tissue-conditioned supernatants induced by infection was measured over time. Yellow indicates novel appearance at 7 h.  Black indicates novel appearance at 24 h.  Orange indicates novel appearance at 48 h.    C) The fold induction of each cytokine was determined at the 24 h time-point. N=8.  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993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18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jamin Nicholas</dc:creator>
  <cp:lastModifiedBy>Benjamin Nicholas</cp:lastModifiedBy>
  <cp:revision>2</cp:revision>
  <dcterms:created xsi:type="dcterms:W3CDTF">2022-06-16T07:50:41Z</dcterms:created>
  <dcterms:modified xsi:type="dcterms:W3CDTF">2022-06-16T09:25:34Z</dcterms:modified>
</cp:coreProperties>
</file>